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0AD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2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A7ABAD-9D29-4DB8-A08A-9C79D4B9B5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A80DB7D-B88C-42D1-B79C-0F712801C8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237B53B-4704-465D-B875-F014FF116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09DC6B-DB00-40B4-927F-A7D04D209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69EE2BD-8366-4A8D-AD32-931A329ED3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8011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87EF56-89DE-4A9E-AACE-940FFC355E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CDD43B2-5FBE-4C25-8DEE-AE1CD782DF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D57C717-69A5-464F-B8C0-B8713EB40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71300A3-AA96-4B4F-8C6C-A1937D815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3946BD7-7D88-4EDB-882A-08F54E7E9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142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FE93668-A71B-41A4-B44C-7BD1219498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1ED001E-9C25-4AB5-966F-717ADF773F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0B0F564-0B5C-4244-B360-ED7930921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C72221C-7B5E-468C-A380-F48197938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329D62C-3F88-4EC0-831C-1B18383396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1622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5310AA5-9070-4111-A8C0-CE23B37491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D6E1465-3AF4-424A-B3B6-12BB433AD7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F5BA675-96B6-4EC5-B425-07452FAB6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9EFDE3F-3EC9-49F0-98E7-1A23B7191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B1C9640-A69B-456C-9B9E-D719BF2EB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5957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4A966D2-1290-482E-A393-63F4054B5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65B8831-0A0B-4C46-B369-021DDC26F9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53D97AA-DDC2-40B5-9976-08D568B700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0530B15-49F0-4BB5-B563-E8EEB4803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F3271D-1465-48D2-A56B-8A7C3F7F8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2629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5585CA8-8815-4010-B52B-F6E182FC98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342F890-C836-4C71-9B39-C2D129C65B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059A104-6481-400C-B8DD-01CB53DC93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4DBED52-7BA7-40B8-98D7-3D803F1ED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8C57CB0-1793-4EC1-8C65-72DBAFF124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77F12ED-640C-4493-A386-2E1EECBAD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3752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FAFA550-FCDF-485F-B7B9-8424B35266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990040F-10F5-40A3-8A06-1D507C9FFB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5F07869-52DF-4D6E-A3D2-62B0F9E342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7F390FDF-4D83-4A6C-AD15-283C44F2E0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7D89F8E-4C7C-4372-9DE1-73CF927334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6956934C-0C48-4FF0-918A-E7E06B4BF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DAE90FBF-78D3-4AEE-9F43-F06DA602F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4694763-1B26-4A46-8543-261DE700E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0849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9EBCD2-E71C-45D5-B099-CD16CF0088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D32004B-DAAA-4792-9C4A-0416ECF1A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E9FC021-EB27-4D8F-84F4-CF6567FD3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0992326-29A4-4E0D-90D0-13976ADE1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4995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124F3B8-0094-4407-A165-E22908F45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FB438C83-31C5-482E-8006-E650796F2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B8D75921-661E-45C8-8F94-84C37BE528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021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5A0A498-47D1-4849-8B2A-55995D80B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8BF048C-C4C9-4A14-BAD1-15F70261ED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67BE833-3698-4DED-AC9E-57F7609A6E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D21552C-3742-47C9-977E-616289C40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6BEE045-BE20-4EB7-A502-9949EBDA3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8B4FDF0-AA62-4AAA-97A9-2EB2D240D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4923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CAD47FC-AD86-4C29-B8CE-E128DD526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4A114685-A5EA-4FC8-BE51-D76E08246E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067846E-5E2D-42C0-AF54-F6DFFEFDF9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472B7E2-EB60-4B75-966C-269877BD94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BE5D849-4A3D-48C0-A4F2-583D03541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E373044-9D53-48E4-BDAF-16852D8CF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823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39BE6F6-0EC7-4F91-8BA4-7AD5AFCAC1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DD4478E-5745-4503-A7A3-5E67294AAA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4F474B3-A0CD-4BA6-9DFF-4706FB22A3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8A0C61-8B1A-4482-B359-A38358894389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7AF6E6A-6D8E-459D-8E97-AF12E0B059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A8F5669-2B5D-4B3E-B823-ECF524C6FB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D6AD2B-71D0-49B0-B086-B62B5146E4D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9177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B66E4288-C88C-4758-BAE6-F72BE13737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7534" y="0"/>
            <a:ext cx="6858000" cy="6858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265E54A-D7A9-4F28-9034-E887EC0BE4CD}"/>
              </a:ext>
            </a:extLst>
          </p:cNvPr>
          <p:cNvSpPr/>
          <p:nvPr/>
        </p:nvSpPr>
        <p:spPr>
          <a:xfrm>
            <a:off x="9135534" y="2556296"/>
            <a:ext cx="168751" cy="20205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rtlCol="0" anchor="ctr"/>
          <a:lstStyle/>
          <a:p>
            <a:pPr algn="ctr"/>
            <a:r>
              <a:rPr lang="fr-FR" sz="1400" dirty="0" err="1">
                <a:solidFill>
                  <a:schemeClr val="tx1"/>
                </a:solidFill>
              </a:rPr>
              <a:t>Nucleotide</a:t>
            </a:r>
            <a:r>
              <a:rPr lang="fr-FR" sz="1400" dirty="0">
                <a:solidFill>
                  <a:schemeClr val="tx1"/>
                </a:solidFill>
              </a:rPr>
              <a:t> distance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40BD35C-8063-441C-A3FE-0303383F5C51}"/>
              </a:ext>
            </a:extLst>
          </p:cNvPr>
          <p:cNvSpPr/>
          <p:nvPr/>
        </p:nvSpPr>
        <p:spPr>
          <a:xfrm>
            <a:off x="9078425" y="3278725"/>
            <a:ext cx="57109" cy="27322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8" name="Connecteur droit avec flèche 7">
            <a:extLst>
              <a:ext uri="{FF2B5EF4-FFF2-40B4-BE49-F238E27FC236}">
                <a16:creationId xmlns:a16="http://schemas.microsoft.com/office/drawing/2014/main" id="{93639790-6E57-48CE-9156-88DBA31BE2E1}"/>
              </a:ext>
            </a:extLst>
          </p:cNvPr>
          <p:cNvCxnSpPr>
            <a:cxnSpLocks/>
          </p:cNvCxnSpPr>
          <p:nvPr/>
        </p:nvCxnSpPr>
        <p:spPr>
          <a:xfrm flipV="1">
            <a:off x="1852706" y="3429000"/>
            <a:ext cx="633506" cy="1229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ZoneTexte 11">
            <a:extLst>
              <a:ext uri="{FF2B5EF4-FFF2-40B4-BE49-F238E27FC236}">
                <a16:creationId xmlns:a16="http://schemas.microsoft.com/office/drawing/2014/main" id="{C1837743-7C53-46C9-B96E-196C07AFF0FB}"/>
              </a:ext>
            </a:extLst>
          </p:cNvPr>
          <p:cNvSpPr txBox="1"/>
          <p:nvPr/>
        </p:nvSpPr>
        <p:spPr>
          <a:xfrm>
            <a:off x="546848" y="3345025"/>
            <a:ext cx="1225704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/>
              <a:t>tseV</a:t>
            </a:r>
            <a:r>
              <a:rPr lang="fr-FR" sz="1600" b="1" dirty="0"/>
              <a:t>_M1</a:t>
            </a:r>
          </a:p>
          <a:p>
            <a:pPr algn="ctr"/>
            <a:r>
              <a:rPr lang="fr-FR" sz="1400" dirty="0"/>
              <a:t>% of </a:t>
            </a:r>
            <a:r>
              <a:rPr lang="fr-FR" sz="1400" dirty="0" err="1"/>
              <a:t>identity</a:t>
            </a:r>
            <a:r>
              <a:rPr lang="fr-FR" sz="1400" dirty="0"/>
              <a:t>  Max-Min [100-95%]</a:t>
            </a:r>
          </a:p>
        </p:txBody>
      </p:sp>
      <p:cxnSp>
        <p:nvCxnSpPr>
          <p:cNvPr id="14" name="Connecteur droit avec flèche 13">
            <a:extLst>
              <a:ext uri="{FF2B5EF4-FFF2-40B4-BE49-F238E27FC236}">
                <a16:creationId xmlns:a16="http://schemas.microsoft.com/office/drawing/2014/main" id="{1E956E04-759B-450A-88F3-CCF51DECE04D}"/>
              </a:ext>
            </a:extLst>
          </p:cNvPr>
          <p:cNvCxnSpPr>
            <a:cxnSpLocks/>
          </p:cNvCxnSpPr>
          <p:nvPr/>
        </p:nvCxnSpPr>
        <p:spPr>
          <a:xfrm flipH="1">
            <a:off x="8445928" y="5796116"/>
            <a:ext cx="854136" cy="2102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>
            <a:extLst>
              <a:ext uri="{FF2B5EF4-FFF2-40B4-BE49-F238E27FC236}">
                <a16:creationId xmlns:a16="http://schemas.microsoft.com/office/drawing/2014/main" id="{C84018E8-D72D-4FD3-9B9F-2E16C687AE56}"/>
              </a:ext>
            </a:extLst>
          </p:cNvPr>
          <p:cNvSpPr txBox="1"/>
          <p:nvPr/>
        </p:nvSpPr>
        <p:spPr>
          <a:xfrm>
            <a:off x="9215689" y="5378014"/>
            <a:ext cx="117739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/>
              <a:t>tseV</a:t>
            </a:r>
            <a:r>
              <a:rPr lang="fr-FR" sz="1600" b="1" dirty="0"/>
              <a:t>_M2</a:t>
            </a:r>
          </a:p>
          <a:p>
            <a:pPr algn="ctr"/>
            <a:r>
              <a:rPr lang="fr-FR" sz="1400" dirty="0"/>
              <a:t>% of </a:t>
            </a:r>
            <a:r>
              <a:rPr lang="fr-FR" sz="1400" dirty="0" err="1"/>
              <a:t>identity</a:t>
            </a:r>
            <a:endParaRPr lang="fr-FR" sz="1400" dirty="0"/>
          </a:p>
          <a:p>
            <a:pPr algn="ctr"/>
            <a:r>
              <a:rPr lang="fr-FR" sz="1400"/>
              <a:t>Max-Min</a:t>
            </a:r>
            <a:endParaRPr lang="fr-FR" sz="1400" dirty="0"/>
          </a:p>
          <a:p>
            <a:pPr algn="ctr"/>
            <a:r>
              <a:rPr lang="fr-FR" sz="1200" dirty="0"/>
              <a:t>[100-48%]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85B4BAA-7C9A-4125-B2C4-4177F85192ED}"/>
              </a:ext>
            </a:extLst>
          </p:cNvPr>
          <p:cNvSpPr/>
          <p:nvPr/>
        </p:nvSpPr>
        <p:spPr>
          <a:xfrm>
            <a:off x="7404847" y="5378014"/>
            <a:ext cx="1041081" cy="103473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1E9D813-17E7-4B44-8CD5-3AEFE73EA42E}"/>
              </a:ext>
            </a:extLst>
          </p:cNvPr>
          <p:cNvSpPr/>
          <p:nvPr/>
        </p:nvSpPr>
        <p:spPr>
          <a:xfrm>
            <a:off x="2486212" y="448887"/>
            <a:ext cx="4918635" cy="492912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67EE657-82CB-B585-84C5-5EC9800865E8}"/>
              </a:ext>
            </a:extLst>
          </p:cNvPr>
          <p:cNvSpPr/>
          <p:nvPr/>
        </p:nvSpPr>
        <p:spPr>
          <a:xfrm>
            <a:off x="5198724" y="328773"/>
            <a:ext cx="507810" cy="1201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B1B2CCF-3F74-92B9-725A-3C94B5B643DB}"/>
              </a:ext>
            </a:extLst>
          </p:cNvPr>
          <p:cNvSpPr/>
          <p:nvPr/>
        </p:nvSpPr>
        <p:spPr>
          <a:xfrm>
            <a:off x="3989239" y="161096"/>
            <a:ext cx="3260128" cy="227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i="1" dirty="0" err="1">
                <a:solidFill>
                  <a:schemeClr val="tx1"/>
                </a:solidFill>
              </a:rPr>
              <a:t>tseV</a:t>
            </a:r>
            <a:r>
              <a:rPr lang="fr-FR" i="1" dirty="0">
                <a:solidFill>
                  <a:schemeClr val="tx1"/>
                </a:solidFill>
              </a:rPr>
              <a:t> </a:t>
            </a:r>
            <a:r>
              <a:rPr lang="fr-FR" dirty="0" err="1">
                <a:solidFill>
                  <a:schemeClr val="tx1"/>
                </a:solidFill>
              </a:rPr>
              <a:t>nucleotide</a:t>
            </a:r>
            <a:r>
              <a:rPr lang="fr-FR" dirty="0">
                <a:solidFill>
                  <a:schemeClr val="tx1"/>
                </a:solidFill>
              </a:rPr>
              <a:t> distance</a:t>
            </a:r>
          </a:p>
        </p:txBody>
      </p:sp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899D910B-60E2-405B-942F-FA36F68FFB9A}"/>
              </a:ext>
            </a:extLst>
          </p:cNvPr>
          <p:cNvCxnSpPr/>
          <p:nvPr/>
        </p:nvCxnSpPr>
        <p:spPr>
          <a:xfrm>
            <a:off x="3012141" y="2248348"/>
            <a:ext cx="62394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4" name="Groupe 33">
            <a:extLst>
              <a:ext uri="{FF2B5EF4-FFF2-40B4-BE49-F238E27FC236}">
                <a16:creationId xmlns:a16="http://schemas.microsoft.com/office/drawing/2014/main" id="{16F523B5-1B96-4F94-A8C7-2582E68D2787}"/>
              </a:ext>
            </a:extLst>
          </p:cNvPr>
          <p:cNvGrpSpPr/>
          <p:nvPr/>
        </p:nvGrpSpPr>
        <p:grpSpPr>
          <a:xfrm>
            <a:off x="2483141" y="6416331"/>
            <a:ext cx="5962787" cy="224900"/>
            <a:chOff x="2483141" y="6416331"/>
            <a:chExt cx="5962787" cy="224900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C3782F6B-E86D-4248-B490-98A37F6872A0}"/>
                </a:ext>
              </a:extLst>
            </p:cNvPr>
            <p:cNvSpPr/>
            <p:nvPr/>
          </p:nvSpPr>
          <p:spPr>
            <a:xfrm>
              <a:off x="2531393" y="6418205"/>
              <a:ext cx="538051" cy="223026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67B3676E-3249-4B8A-875B-5B3CD30147B7}"/>
                </a:ext>
              </a:extLst>
            </p:cNvPr>
            <p:cNvSpPr/>
            <p:nvPr/>
          </p:nvSpPr>
          <p:spPr>
            <a:xfrm>
              <a:off x="2483141" y="6418205"/>
              <a:ext cx="48252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343C8764-8E9E-43E4-8C8A-5E32EF2FA9AE}"/>
                </a:ext>
              </a:extLst>
            </p:cNvPr>
            <p:cNvSpPr/>
            <p:nvPr/>
          </p:nvSpPr>
          <p:spPr>
            <a:xfrm>
              <a:off x="3067673" y="6417989"/>
              <a:ext cx="176089" cy="22302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B7ACCFFF-CAEA-4CC1-88AC-DB3785828DA6}"/>
                </a:ext>
              </a:extLst>
            </p:cNvPr>
            <p:cNvSpPr/>
            <p:nvPr/>
          </p:nvSpPr>
          <p:spPr>
            <a:xfrm>
              <a:off x="3243762" y="6417989"/>
              <a:ext cx="48252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5092C4AF-032E-4569-9D63-94841E9A744E}"/>
                </a:ext>
              </a:extLst>
            </p:cNvPr>
            <p:cNvSpPr/>
            <p:nvPr/>
          </p:nvSpPr>
          <p:spPr>
            <a:xfrm>
              <a:off x="3618377" y="6417989"/>
              <a:ext cx="84451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0C0B1418-D92E-4C9F-B60D-B6972947D39F}"/>
                </a:ext>
              </a:extLst>
            </p:cNvPr>
            <p:cNvSpPr/>
            <p:nvPr/>
          </p:nvSpPr>
          <p:spPr>
            <a:xfrm>
              <a:off x="7111048" y="6418033"/>
              <a:ext cx="48252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41945968-3D5C-4546-AE46-0003A04504DD}"/>
                </a:ext>
              </a:extLst>
            </p:cNvPr>
            <p:cNvSpPr/>
            <p:nvPr/>
          </p:nvSpPr>
          <p:spPr>
            <a:xfrm>
              <a:off x="3700361" y="6417714"/>
              <a:ext cx="3415148" cy="223026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CA3CF789-A8AC-4055-8DAF-0ED82B7D6FF9}"/>
                </a:ext>
              </a:extLst>
            </p:cNvPr>
            <p:cNvSpPr/>
            <p:nvPr/>
          </p:nvSpPr>
          <p:spPr>
            <a:xfrm>
              <a:off x="7154840" y="6417714"/>
              <a:ext cx="250007" cy="223026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7D105EDE-0760-43AF-9002-9DF0606CECFD}"/>
                </a:ext>
              </a:extLst>
            </p:cNvPr>
            <p:cNvSpPr/>
            <p:nvPr/>
          </p:nvSpPr>
          <p:spPr>
            <a:xfrm>
              <a:off x="3289820" y="6418033"/>
              <a:ext cx="328557" cy="22302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95791027-A903-461D-927F-017D5AFCEBBC}"/>
                </a:ext>
              </a:extLst>
            </p:cNvPr>
            <p:cNvSpPr/>
            <p:nvPr/>
          </p:nvSpPr>
          <p:spPr>
            <a:xfrm>
              <a:off x="7631989" y="6417296"/>
              <a:ext cx="197686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18A7D1C5-A0A0-4005-BC9B-0C2A33009E95}"/>
                </a:ext>
              </a:extLst>
            </p:cNvPr>
            <p:cNvSpPr/>
            <p:nvPr/>
          </p:nvSpPr>
          <p:spPr>
            <a:xfrm>
              <a:off x="7446968" y="6417714"/>
              <a:ext cx="185021" cy="22302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46AF74ED-1430-4166-93B9-6BC101C23326}"/>
                </a:ext>
              </a:extLst>
            </p:cNvPr>
            <p:cNvSpPr/>
            <p:nvPr/>
          </p:nvSpPr>
          <p:spPr>
            <a:xfrm>
              <a:off x="7401681" y="6418132"/>
              <a:ext cx="45719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0EF05679-6DD7-4664-AFC1-6A74E2E0E50F}"/>
                </a:ext>
              </a:extLst>
            </p:cNvPr>
            <p:cNvSpPr/>
            <p:nvPr/>
          </p:nvSpPr>
          <p:spPr>
            <a:xfrm>
              <a:off x="7894392" y="6417949"/>
              <a:ext cx="551536" cy="22302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84AD01E3-017D-4038-80CC-7AF7B3DA5A1E}"/>
                </a:ext>
              </a:extLst>
            </p:cNvPr>
            <p:cNvSpPr/>
            <p:nvPr/>
          </p:nvSpPr>
          <p:spPr>
            <a:xfrm>
              <a:off x="7826547" y="6416331"/>
              <a:ext cx="70630" cy="223026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35" name="Groupe 34">
            <a:extLst>
              <a:ext uri="{FF2B5EF4-FFF2-40B4-BE49-F238E27FC236}">
                <a16:creationId xmlns:a16="http://schemas.microsoft.com/office/drawing/2014/main" id="{51EFDA08-2494-4C58-A9C4-43F66AB30380}"/>
              </a:ext>
            </a:extLst>
          </p:cNvPr>
          <p:cNvGrpSpPr/>
          <p:nvPr/>
        </p:nvGrpSpPr>
        <p:grpSpPr>
          <a:xfrm rot="5400000">
            <a:off x="-609481" y="3322204"/>
            <a:ext cx="5962787" cy="224900"/>
            <a:chOff x="2483141" y="6416331"/>
            <a:chExt cx="5962787" cy="224900"/>
          </a:xfrm>
        </p:grpSpPr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3C7CBBBF-1F2A-4179-B239-7190ED46B1B5}"/>
                </a:ext>
              </a:extLst>
            </p:cNvPr>
            <p:cNvSpPr/>
            <p:nvPr/>
          </p:nvSpPr>
          <p:spPr>
            <a:xfrm>
              <a:off x="2531393" y="6418205"/>
              <a:ext cx="538051" cy="223026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B9D965E8-2972-49F3-82B1-2188D5F3B351}"/>
                </a:ext>
              </a:extLst>
            </p:cNvPr>
            <p:cNvSpPr/>
            <p:nvPr/>
          </p:nvSpPr>
          <p:spPr>
            <a:xfrm>
              <a:off x="2483141" y="6418205"/>
              <a:ext cx="48252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BB324E0C-7D4B-4852-A17C-635C287756EE}"/>
                </a:ext>
              </a:extLst>
            </p:cNvPr>
            <p:cNvSpPr/>
            <p:nvPr/>
          </p:nvSpPr>
          <p:spPr>
            <a:xfrm>
              <a:off x="3067673" y="6417989"/>
              <a:ext cx="176089" cy="22302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EBEC1868-229B-4C35-B62C-CAC5BD1259E4}"/>
                </a:ext>
              </a:extLst>
            </p:cNvPr>
            <p:cNvSpPr/>
            <p:nvPr/>
          </p:nvSpPr>
          <p:spPr>
            <a:xfrm>
              <a:off x="3243762" y="6417989"/>
              <a:ext cx="48252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74780BBE-C58E-437A-93AD-2F45B3894031}"/>
                </a:ext>
              </a:extLst>
            </p:cNvPr>
            <p:cNvSpPr/>
            <p:nvPr/>
          </p:nvSpPr>
          <p:spPr>
            <a:xfrm>
              <a:off x="3618377" y="6417989"/>
              <a:ext cx="84451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933AB121-400D-40C4-87A4-EE768A3C3A32}"/>
                </a:ext>
              </a:extLst>
            </p:cNvPr>
            <p:cNvSpPr/>
            <p:nvPr/>
          </p:nvSpPr>
          <p:spPr>
            <a:xfrm>
              <a:off x="7111048" y="6418033"/>
              <a:ext cx="48252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DE0EC3F0-E62D-4DAA-B7F2-11F73A9385F9}"/>
                </a:ext>
              </a:extLst>
            </p:cNvPr>
            <p:cNvSpPr/>
            <p:nvPr/>
          </p:nvSpPr>
          <p:spPr>
            <a:xfrm>
              <a:off x="3700361" y="6417714"/>
              <a:ext cx="3415148" cy="223026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76E0B5AD-DCE5-4B6E-A6FF-065F262F51FD}"/>
                </a:ext>
              </a:extLst>
            </p:cNvPr>
            <p:cNvSpPr/>
            <p:nvPr/>
          </p:nvSpPr>
          <p:spPr>
            <a:xfrm>
              <a:off x="7154841" y="6417714"/>
              <a:ext cx="252384" cy="223026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0FFD2B9A-68C0-4B18-BDC9-5FE0EB7CC0CF}"/>
                </a:ext>
              </a:extLst>
            </p:cNvPr>
            <p:cNvSpPr/>
            <p:nvPr/>
          </p:nvSpPr>
          <p:spPr>
            <a:xfrm>
              <a:off x="3289820" y="6418033"/>
              <a:ext cx="328557" cy="22302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FF2B7638-6186-4BBA-B41F-8B79503FFAC5}"/>
                </a:ext>
              </a:extLst>
            </p:cNvPr>
            <p:cNvSpPr/>
            <p:nvPr/>
          </p:nvSpPr>
          <p:spPr>
            <a:xfrm>
              <a:off x="7631989" y="6417296"/>
              <a:ext cx="197686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106B5C9E-2B34-470C-9C8F-DEB266CEDC5A}"/>
                </a:ext>
              </a:extLst>
            </p:cNvPr>
            <p:cNvSpPr/>
            <p:nvPr/>
          </p:nvSpPr>
          <p:spPr>
            <a:xfrm>
              <a:off x="7452510" y="6417714"/>
              <a:ext cx="182643" cy="22302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A60CDD0-79E9-42B6-A59A-4FEA506F23AF}"/>
                </a:ext>
              </a:extLst>
            </p:cNvPr>
            <p:cNvSpPr/>
            <p:nvPr/>
          </p:nvSpPr>
          <p:spPr>
            <a:xfrm>
              <a:off x="7407223" y="6418132"/>
              <a:ext cx="45719" cy="22302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382A2140-59AA-472A-97F7-CABDAB36042A}"/>
                </a:ext>
              </a:extLst>
            </p:cNvPr>
            <p:cNvSpPr/>
            <p:nvPr/>
          </p:nvSpPr>
          <p:spPr>
            <a:xfrm>
              <a:off x="7894392" y="6417949"/>
              <a:ext cx="551536" cy="22302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82E9F7EC-0099-480B-9FC7-E4A89C63B19A}"/>
                </a:ext>
              </a:extLst>
            </p:cNvPr>
            <p:cNvSpPr/>
            <p:nvPr/>
          </p:nvSpPr>
          <p:spPr>
            <a:xfrm>
              <a:off x="7826547" y="6416331"/>
              <a:ext cx="70630" cy="223026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56" name="Groupe 55">
            <a:extLst>
              <a:ext uri="{FF2B5EF4-FFF2-40B4-BE49-F238E27FC236}">
                <a16:creationId xmlns:a16="http://schemas.microsoft.com/office/drawing/2014/main" id="{AD87B844-3701-49C4-B0C5-7B64D4B5FCE9}"/>
              </a:ext>
            </a:extLst>
          </p:cNvPr>
          <p:cNvGrpSpPr/>
          <p:nvPr/>
        </p:nvGrpSpPr>
        <p:grpSpPr>
          <a:xfrm>
            <a:off x="9344212" y="273739"/>
            <a:ext cx="2973294" cy="941438"/>
            <a:chOff x="9344212" y="273739"/>
            <a:chExt cx="2973294" cy="941438"/>
          </a:xfrm>
        </p:grpSpPr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39ECEEC7-4BCE-4231-BA32-EE5442EFE3A0}"/>
                </a:ext>
              </a:extLst>
            </p:cNvPr>
            <p:cNvSpPr txBox="1"/>
            <p:nvPr/>
          </p:nvSpPr>
          <p:spPr>
            <a:xfrm>
              <a:off x="9705788" y="273739"/>
              <a:ext cx="23509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morganii</a:t>
              </a:r>
              <a:r>
                <a:rPr lang="en-US" sz="14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subsp. </a:t>
              </a:r>
              <a:r>
                <a:rPr lang="en-US" sz="1400" i="1" dirty="0">
                  <a:solidFill>
                    <a:srgbClr val="1F1F1F"/>
                  </a:solidFill>
                  <a:ea typeface="Times New Roman" panose="02020603050405020304" pitchFamily="18" charset="0"/>
                </a:rPr>
                <a:t>morganii</a:t>
              </a:r>
              <a:endParaRPr lang="fr-FR" sz="1400" dirty="0"/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277E950D-9F5B-4166-9BC1-9D12346FA185}"/>
                </a:ext>
              </a:extLst>
            </p:cNvPr>
            <p:cNvSpPr txBox="1"/>
            <p:nvPr/>
          </p:nvSpPr>
          <p:spPr>
            <a:xfrm>
              <a:off x="9705788" y="609776"/>
              <a:ext cx="26117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morganii</a:t>
              </a:r>
              <a:r>
                <a:rPr lang="en-US" sz="14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subsp. </a:t>
              </a:r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intermedius</a:t>
              </a:r>
              <a:endParaRPr lang="fr-FR" sz="1400" i="1" dirty="0"/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4C7C54B3-F0D6-4C59-9D0A-A1D740D27605}"/>
                </a:ext>
              </a:extLst>
            </p:cNvPr>
            <p:cNvSpPr txBox="1"/>
            <p:nvPr/>
          </p:nvSpPr>
          <p:spPr>
            <a:xfrm>
              <a:off x="9705788" y="907400"/>
              <a:ext cx="26117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</a:t>
              </a:r>
              <a:r>
                <a:rPr lang="en-US" sz="1400" i="1" dirty="0" err="1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sibonii</a:t>
              </a:r>
              <a:endParaRPr lang="fr-FR" sz="1400" dirty="0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9394DDBD-DCD4-4496-8DC7-6E5AB2DFDB0E}"/>
                </a:ext>
              </a:extLst>
            </p:cNvPr>
            <p:cNvSpPr/>
            <p:nvPr/>
          </p:nvSpPr>
          <p:spPr>
            <a:xfrm>
              <a:off x="9357375" y="962486"/>
              <a:ext cx="348413" cy="234709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D37448F9-455A-47AE-A79E-4E0D181CDA1C}"/>
                </a:ext>
              </a:extLst>
            </p:cNvPr>
            <p:cNvSpPr/>
            <p:nvPr/>
          </p:nvSpPr>
          <p:spPr>
            <a:xfrm>
              <a:off x="9357375" y="625609"/>
              <a:ext cx="348413" cy="234709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D3E62AE1-BE38-47D3-BA87-284CA14E2D66}"/>
                </a:ext>
              </a:extLst>
            </p:cNvPr>
            <p:cNvSpPr/>
            <p:nvPr/>
          </p:nvSpPr>
          <p:spPr>
            <a:xfrm>
              <a:off x="9344212" y="310272"/>
              <a:ext cx="348413" cy="234709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20817439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40</Words>
  <Application>Microsoft Macintosh PowerPoint</Application>
  <PresentationFormat>Grand écran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thilde Duque</dc:creator>
  <cp:lastModifiedBy>DORTET Laurent</cp:lastModifiedBy>
  <cp:revision>19</cp:revision>
  <dcterms:created xsi:type="dcterms:W3CDTF">2025-09-17T10:00:51Z</dcterms:created>
  <dcterms:modified xsi:type="dcterms:W3CDTF">2025-12-24T14:14:35Z</dcterms:modified>
</cp:coreProperties>
</file>